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73D18-B77F-4CFC-8025-71DAEE574C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EF0A6-772C-4C37-9BE3-6223310C1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2C899-F5B2-4A24-8A7C-D7F37717C9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BF868-3F48-484A-BBC8-722E0C106E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D01D0-D27A-4509-90F0-49CF6822AC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A8BF7-B9D5-49A6-B622-98C1FF223E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66BC1-6706-4690-86C8-3426EB240E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0BE84-086A-49BA-B892-2C03509686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59403-BAB8-4A0C-A59A-F692299060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C327A-9BA6-439A-876F-EB7B219E7D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BF5E5E-11EB-41F6-AD9B-A592118F60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73CA1-2B23-4854-8A5B-48833777C5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18FCF2-4A2F-47CB-B7BE-0C6A60CD884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541840" y="1111320"/>
            <a:ext cx="322560" cy="176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829480" y="995400"/>
            <a:ext cx="347400" cy="515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211640" y="876240"/>
            <a:ext cx="225360" cy="2905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808080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348080" y="1019160"/>
            <a:ext cx="193680" cy="3445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808080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384880" y="1660680"/>
            <a:ext cx="0" cy="53640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4824000" y="2760840"/>
            <a:ext cx="399960" cy="936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481640" y="2400480"/>
            <a:ext cx="304560" cy="873000"/>
          </a:xfrm>
          <a:prstGeom prst="rect">
            <a:avLst/>
          </a:prstGeom>
          <a:solidFill>
            <a:srgbClr val="808080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543560" y="2800440"/>
            <a:ext cx="1476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549680" y="3033720"/>
            <a:ext cx="1494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532400" y="2624040"/>
            <a:ext cx="14904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87760" y="2565360"/>
            <a:ext cx="8762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SDS-PAG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4938480" y="2400120"/>
            <a:ext cx="914400" cy="273240"/>
          </a:xfrm>
          <a:prstGeom prst="flowChartOnlineStorage">
            <a:avLst/>
          </a:prstGeom>
          <a:gradFill rotWithShape="0">
            <a:gsLst>
              <a:gs pos="0">
                <a:srgbClr val="000000"/>
              </a:gs>
              <a:gs pos="100000">
                <a:srgbClr val="fefefe"/>
              </a:gs>
            </a:gsLst>
            <a:lin ang="16200000"/>
          </a:gra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529240" y="2725560"/>
            <a:ext cx="251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roteins eluted with 6 M ure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383080" y="3029040"/>
            <a:ext cx="0" cy="44748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192480" y="4361400"/>
            <a:ext cx="4444920" cy="459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ALDI Online Database Searc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ascot software (http://www.matrixscience.co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743360" y="3508920"/>
            <a:ext cx="1397160" cy="27648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C-MS/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396040" y="3854520"/>
            <a:ext cx="0" cy="4460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402160" y="4879800"/>
            <a:ext cx="0" cy="3128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097880" y="5205960"/>
            <a:ext cx="2003400" cy="27648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ngenuity Pathway 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2374920" y="1376280"/>
            <a:ext cx="2074680" cy="291456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1192320" y="2079720"/>
            <a:ext cx="1376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ilver-sta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g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184400" y="3836880"/>
            <a:ext cx="1468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R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wester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l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900760" y="981000"/>
            <a:ext cx="171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nti-FL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M2 Affinity g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428840" y="507960"/>
            <a:ext cx="3176640" cy="84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1793 or A549 cells treated wi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tOH or 10 nM E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for 1 h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Whole cell lysates incubat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with rhER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-FLAG </a:t>
            </a:r>
            <a:r>
              <a:rPr b="1" lang="en-US" sz="1200" spc="-1" strike="noStrike">
                <a:solidFill>
                  <a:srgbClr val="0000ff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or 1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408280" y="3097080"/>
            <a:ext cx="127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Trypsin diges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952960" y="2106720"/>
            <a:ext cx="1746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inse 3 times TBS buff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ncluded 150 mM NaCl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0.5% NP-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H="1" rot="14605200">
            <a:off x="5285880" y="990360"/>
            <a:ext cx="100080" cy="79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449600" y="971640"/>
            <a:ext cx="1097280" cy="495360"/>
          </a:xfrm>
          <a:prstGeom prst="ellipse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FLAG-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R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421160" y="1249200"/>
            <a:ext cx="225360" cy="33048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808080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9668600">
            <a:off x="4535640" y="1509480"/>
            <a:ext cx="398160" cy="33012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808080"/>
              </a:gs>
            </a:gsLst>
            <a:lin ang="12732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H="1" rot="17748600">
            <a:off x="5183640" y="570600"/>
            <a:ext cx="100080" cy="793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554360" y="596880"/>
            <a:ext cx="360720" cy="43020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808080"/>
              </a:gs>
            </a:gsLst>
            <a:lin ang="108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8163200">
            <a:off x="4404600" y="665640"/>
            <a:ext cx="347760" cy="488880"/>
          </a:xfrm>
          <a:prstGeom prst="ellipse">
            <a:avLst/>
          </a:prstGeom>
          <a:gradFill rotWithShape="0">
            <a:gsLst>
              <a:gs pos="0">
                <a:srgbClr val="ffffff"/>
              </a:gs>
              <a:gs pos="100000">
                <a:srgbClr val="808080"/>
              </a:gs>
            </a:gsLst>
            <a:lin ang="14238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562720" y="2260440"/>
            <a:ext cx="342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914400" y="5784840"/>
            <a:ext cx="7521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Supplemental Figure 1: Experimental design for identification of ER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FLAG interacting proteins in transfected A549 and H1793 lung adenocarcinoma cells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0T14:43:40Z</dcterms:created>
  <dc:creator>Lab User</dc:creator>
  <dc:description/>
  <dc:language>en-US</dc:language>
  <cp:lastModifiedBy>Carolyn M Klinge</cp:lastModifiedBy>
  <dcterms:modified xsi:type="dcterms:W3CDTF">2011-09-19T18:35:38Z</dcterms:modified>
  <cp:revision>24</cp:revision>
  <dc:subject/>
  <dc:title>Slide 1</dc:title>
</cp:coreProperties>
</file>